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47"/>
    <p:restoredTop sz="95946"/>
  </p:normalViewPr>
  <p:slideViewPr>
    <p:cSldViewPr snapToGrid="0" snapToObjects="1">
      <p:cViewPr varScale="1">
        <p:scale>
          <a:sx n="114" d="100"/>
          <a:sy n="114" d="100"/>
        </p:scale>
        <p:origin x="18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6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213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06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22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390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360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773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12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988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786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381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784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hdphoto" Target="../media/hdphoto1.wdp"/><Relationship Id="rId7" Type="http://schemas.microsoft.com/office/2007/relationships/hdphoto" Target="../media/hdphoto4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3.wdp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528454" y="4890140"/>
            <a:ext cx="7745751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The demethylation of tRNA-Arg-TCT-4-1 gene is associated with an increased tRNA expression in KIRP and UCEC TCGA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Frequency of tRNA-Arg-TCT-4-1 hypomethylation in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derived from TCGA according to the tissue of origin. 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tRNA-Arg-TCT-4-1 expression is higher in those KIRP (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to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and UCEC (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below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TCGA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where this gene is hypomethylated. Statistical differences in tRNA expression between groups of samples were determined using a two-sided Mann-Whitney U-test; *** p &lt; 0.001. Samples were considered hypomethylated or hypermethylated when tRNA-Arg-TCT-4-1 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value was lower or higher than 0.33, respectively.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06ECECE-756C-8E4D-BE07-8E8206C78E94}"/>
              </a:ext>
            </a:extLst>
          </p:cNvPr>
          <p:cNvSpPr txBox="1"/>
          <p:nvPr/>
        </p:nvSpPr>
        <p:spPr>
          <a:xfrm>
            <a:off x="7168152" y="-38461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283E78F-C2AA-4948-B147-8F3BF354BD50}"/>
              </a:ext>
            </a:extLst>
          </p:cNvPr>
          <p:cNvSpPr txBox="1"/>
          <p:nvPr/>
        </p:nvSpPr>
        <p:spPr>
          <a:xfrm>
            <a:off x="5280964" y="56301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57B7AD23-267D-064B-8EC4-C3FC3472196F}"/>
              </a:ext>
            </a:extLst>
          </p:cNvPr>
          <p:cNvGrpSpPr>
            <a:grpSpLocks noChangeAspect="1"/>
          </p:cNvGrpSpPr>
          <p:nvPr/>
        </p:nvGrpSpPr>
        <p:grpSpPr>
          <a:xfrm>
            <a:off x="5619518" y="506665"/>
            <a:ext cx="1403387" cy="4092646"/>
            <a:chOff x="303411" y="2775279"/>
            <a:chExt cx="1350002" cy="3936959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E9E75C99-5E22-B94F-B427-61F53C9DC62D}"/>
                </a:ext>
              </a:extLst>
            </p:cNvPr>
            <p:cNvGrpSpPr/>
            <p:nvPr/>
          </p:nvGrpSpPr>
          <p:grpSpPr>
            <a:xfrm>
              <a:off x="303411" y="4739200"/>
              <a:ext cx="1350002" cy="1973038"/>
              <a:chOff x="-736152" y="4682964"/>
              <a:chExt cx="1350002" cy="1973038"/>
            </a:xfrm>
          </p:grpSpPr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98C09E78-74A6-4943-9344-30F927ACCFD5}"/>
                  </a:ext>
                </a:extLst>
              </p:cNvPr>
              <p:cNvGrpSpPr/>
              <p:nvPr/>
            </p:nvGrpSpPr>
            <p:grpSpPr>
              <a:xfrm>
                <a:off x="-736152" y="4682964"/>
                <a:ext cx="1350002" cy="1814063"/>
                <a:chOff x="1240120" y="4798340"/>
                <a:chExt cx="1350002" cy="1814063"/>
              </a:xfrm>
            </p:grpSpPr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3081FD65-AC82-824C-9876-6C17A68FAE31}"/>
                    </a:ext>
                  </a:extLst>
                </p:cNvPr>
                <p:cNvGrpSpPr/>
                <p:nvPr/>
              </p:nvGrpSpPr>
              <p:grpSpPr>
                <a:xfrm>
                  <a:off x="1897742" y="4798340"/>
                  <a:ext cx="396000" cy="246221"/>
                  <a:chOff x="-192326" y="4815305"/>
                  <a:chExt cx="396000" cy="246221"/>
                </a:xfrm>
              </p:grpSpPr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ADB68D3C-5DE9-BF4D-A74D-50575B0C6E87}"/>
                      </a:ext>
                    </a:extLst>
                  </p:cNvPr>
                  <p:cNvSpPr txBox="1"/>
                  <p:nvPr/>
                </p:nvSpPr>
                <p:spPr>
                  <a:xfrm>
                    <a:off x="-161198" y="4815305"/>
                    <a:ext cx="33374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Helvetica" pitchFamily="2" charset="0"/>
                      </a:rPr>
                      <a:t>***</a:t>
                    </a:r>
                  </a:p>
                </p:txBody>
              </p:sp>
              <p:sp>
                <p:nvSpPr>
                  <p:cNvPr id="42" name="Right Bracket 41">
                    <a:extLst>
                      <a:ext uri="{FF2B5EF4-FFF2-40B4-BE49-F238E27FC236}">
                        <a16:creationId xmlns:a16="http://schemas.microsoft.com/office/drawing/2014/main" id="{60C34694-58B4-F143-A865-67D3DF2B8C7B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-12326" y="4783876"/>
                    <a:ext cx="36000" cy="396000"/>
                  </a:xfrm>
                  <a:prstGeom prst="rightBracket">
                    <a:avLst>
                      <a:gd name="adj" fmla="val 0"/>
                    </a:avLst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pic>
              <p:nvPicPr>
                <p:cNvPr id="40" name="Picture 39" descr="Chart, box and whisker chart&#10;&#10;Description automatically generated">
                  <a:extLst>
                    <a:ext uri="{FF2B5EF4-FFF2-40B4-BE49-F238E27FC236}">
                      <a16:creationId xmlns:a16="http://schemas.microsoft.com/office/drawing/2014/main" id="{02BE0AEF-4509-3546-93A5-8C609AA6B0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5000"/>
                          </a14:imgEffect>
                        </a14:imgLayer>
                      </a14:imgProps>
                    </a:ext>
                  </a:extLst>
                </a:blip>
                <a:srcRect l="-93" r="37593"/>
                <a:stretch/>
              </p:blipFill>
              <p:spPr>
                <a:xfrm>
                  <a:off x="1240120" y="4992403"/>
                  <a:ext cx="1350002" cy="1620000"/>
                </a:xfrm>
                <a:prstGeom prst="rect">
                  <a:avLst/>
                </a:prstGeom>
              </p:spPr>
            </p:pic>
          </p:grp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D615ADA-F5A3-1A46-B8DC-64180B90C5FD}"/>
                  </a:ext>
                </a:extLst>
              </p:cNvPr>
              <p:cNvSpPr txBox="1"/>
              <p:nvPr/>
            </p:nvSpPr>
            <p:spPr>
              <a:xfrm>
                <a:off x="-106050" y="6453548"/>
                <a:ext cx="451041" cy="202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CEC</a:t>
                </a:r>
              </a:p>
            </p:txBody>
          </p:sp>
        </p:grpSp>
        <p:pic>
          <p:nvPicPr>
            <p:cNvPr id="33" name="Picture 32" descr="Chart, box and whisker chart&#10;&#10;Description automatically generated">
              <a:extLst>
                <a:ext uri="{FF2B5EF4-FFF2-40B4-BE49-F238E27FC236}">
                  <a16:creationId xmlns:a16="http://schemas.microsoft.com/office/drawing/2014/main" id="{238AA3B6-F9FC-204D-B057-245499F17B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5000"/>
                      </a14:imgEffect>
                    </a14:imgLayer>
                  </a14:imgProps>
                </a:ext>
              </a:extLst>
            </a:blip>
            <a:srcRect r="38953"/>
            <a:stretch/>
          </p:blipFill>
          <p:spPr>
            <a:xfrm>
              <a:off x="303413" y="2974344"/>
              <a:ext cx="1350000" cy="1620000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57FE6AD-3C45-D64E-A242-FCE94B281480}"/>
                </a:ext>
              </a:extLst>
            </p:cNvPr>
            <p:cNvSpPr txBox="1"/>
            <p:nvPr/>
          </p:nvSpPr>
          <p:spPr>
            <a:xfrm>
              <a:off x="858589" y="4539483"/>
              <a:ext cx="397000" cy="202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KIRP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DCB0951-C670-7547-869D-65398D3514F0}"/>
                </a:ext>
              </a:extLst>
            </p:cNvPr>
            <p:cNvSpPr txBox="1"/>
            <p:nvPr/>
          </p:nvSpPr>
          <p:spPr>
            <a:xfrm>
              <a:off x="975288" y="2775279"/>
              <a:ext cx="274421" cy="202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Helvetica" pitchFamily="2" charset="0"/>
                </a:rPr>
                <a:t>***</a:t>
              </a:r>
            </a:p>
          </p:txBody>
        </p:sp>
        <p:sp>
          <p:nvSpPr>
            <p:cNvPr id="36" name="Right Bracket 35">
              <a:extLst>
                <a:ext uri="{FF2B5EF4-FFF2-40B4-BE49-F238E27FC236}">
                  <a16:creationId xmlns:a16="http://schemas.microsoft.com/office/drawing/2014/main" id="{9D021C3A-AC93-0041-902A-A7FD93E9332C}"/>
                </a:ext>
              </a:extLst>
            </p:cNvPr>
            <p:cNvSpPr/>
            <p:nvPr/>
          </p:nvSpPr>
          <p:spPr>
            <a:xfrm rot="16200000">
              <a:off x="1094498" y="2743848"/>
              <a:ext cx="36000" cy="396000"/>
            </a:xfrm>
            <a:prstGeom prst="rightBracket">
              <a:avLst>
                <a:gd name="adj" fmla="val 0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20" name="Picture 19" descr="Chart, box and whisker chart&#10;&#10;Description automatically generated">
            <a:extLst>
              <a:ext uri="{FF2B5EF4-FFF2-40B4-BE49-F238E27FC236}">
                <a16:creationId xmlns:a16="http://schemas.microsoft.com/office/drawing/2014/main" id="{8F7E3317-459B-E94B-975C-9A76B6B433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62781" t="44337" r="27379" b="35830"/>
          <a:stretch/>
        </p:blipFill>
        <p:spPr>
          <a:xfrm>
            <a:off x="6976447" y="932350"/>
            <a:ext cx="320465" cy="484463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528455" y="56301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0" name="Picture 49" descr="Chart, box and whisker chart&#10;&#10;Description automatically generated">
            <a:extLst>
              <a:ext uri="{FF2B5EF4-FFF2-40B4-BE49-F238E27FC236}">
                <a16:creationId xmlns:a16="http://schemas.microsoft.com/office/drawing/2014/main" id="{38D5EA31-68FC-6042-BD4E-4C08DCF3CF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62781" t="44185" r="27379" b="35830"/>
          <a:stretch/>
        </p:blipFill>
        <p:spPr>
          <a:xfrm>
            <a:off x="6976447" y="2970360"/>
            <a:ext cx="320465" cy="4881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A23D8AB-84B1-0646-88F2-77FD117B4594}"/>
              </a:ext>
            </a:extLst>
          </p:cNvPr>
          <p:cNvSpPr txBox="1"/>
          <p:nvPr/>
        </p:nvSpPr>
        <p:spPr>
          <a:xfrm>
            <a:off x="7246115" y="934242"/>
            <a:ext cx="1011815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50" dirty="0">
                <a:latin typeface="Arial" panose="020B0604020202020204" pitchFamily="34" charset="0"/>
                <a:cs typeface="Arial" panose="020B0604020202020204" pitchFamily="34" charset="0"/>
              </a:rPr>
              <a:t>Hypomethylated</a:t>
            </a:r>
          </a:p>
          <a:p>
            <a:endParaRPr lang="en-US" sz="4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50" dirty="0"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4FF0707-15BB-174C-9205-855078631ABD}"/>
              </a:ext>
            </a:extLst>
          </p:cNvPr>
          <p:cNvSpPr txBox="1"/>
          <p:nvPr/>
        </p:nvSpPr>
        <p:spPr>
          <a:xfrm>
            <a:off x="7246114" y="2970360"/>
            <a:ext cx="1011815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50" dirty="0">
                <a:latin typeface="Arial" panose="020B0604020202020204" pitchFamily="34" charset="0"/>
                <a:cs typeface="Arial" panose="020B0604020202020204" pitchFamily="34" charset="0"/>
              </a:rPr>
              <a:t>Hypomethylated</a:t>
            </a:r>
          </a:p>
          <a:p>
            <a:endParaRPr lang="en-US" sz="4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50" dirty="0"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60EC68D-B21C-2A40-8D2A-E6E34CE31203}"/>
              </a:ext>
            </a:extLst>
          </p:cNvPr>
          <p:cNvSpPr txBox="1"/>
          <p:nvPr/>
        </p:nvSpPr>
        <p:spPr>
          <a:xfrm>
            <a:off x="6986962" y="2759345"/>
            <a:ext cx="1149674" cy="22313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50" b="1" dirty="0">
                <a:latin typeface="Arial" panose="020B0604020202020204" pitchFamily="34" charset="0"/>
                <a:cs typeface="Arial" panose="020B0604020202020204" pitchFamily="34" charset="0"/>
              </a:rPr>
              <a:t>Methylation statu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EC8005D-6429-1746-9686-3704631881C4}"/>
              </a:ext>
            </a:extLst>
          </p:cNvPr>
          <p:cNvSpPr txBox="1"/>
          <p:nvPr/>
        </p:nvSpPr>
        <p:spPr>
          <a:xfrm>
            <a:off x="6986962" y="706446"/>
            <a:ext cx="1149674" cy="22313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50" b="1" dirty="0">
                <a:latin typeface="Arial" panose="020B0604020202020204" pitchFamily="34" charset="0"/>
                <a:cs typeface="Arial" panose="020B0604020202020204" pitchFamily="34" charset="0"/>
              </a:rPr>
              <a:t>Methylation statu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1EB4F08-D427-D445-BB06-B1784CF0CF8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b="5185"/>
          <a:stretch/>
        </p:blipFill>
        <p:spPr>
          <a:xfrm>
            <a:off x="863838" y="887479"/>
            <a:ext cx="4342124" cy="37052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6414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</TotalTime>
  <Words>126</Words>
  <Application>Microsoft Office PowerPoint</Application>
  <PresentationFormat>Presentación en pantalla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GALIDA ROSSELLO TORTELLA</dc:creator>
  <cp:lastModifiedBy>Manel Esteller</cp:lastModifiedBy>
  <cp:revision>25</cp:revision>
  <dcterms:created xsi:type="dcterms:W3CDTF">2021-07-05T11:21:51Z</dcterms:created>
  <dcterms:modified xsi:type="dcterms:W3CDTF">2022-02-02T17:21:31Z</dcterms:modified>
</cp:coreProperties>
</file>